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1" d="100"/>
          <a:sy n="61" d="100"/>
        </p:scale>
        <p:origin x="-139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Twelve hours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xVal>
            <c:numRef>
              <c:f>Sheet11!$Z$14:$Z$24</c:f>
              <c:numCache>
                <c:formatCode>General</c:formatCode>
                <c:ptCount val="11"/>
                <c:pt idx="0">
                  <c:v>5.331792051987002</c:v>
                </c:pt>
                <c:pt idx="1">
                  <c:v>3.400207123726744</c:v>
                </c:pt>
                <c:pt idx="2">
                  <c:v>5.510210862841644</c:v>
                </c:pt>
                <c:pt idx="3">
                  <c:v>6.275981169018492</c:v>
                </c:pt>
                <c:pt idx="4">
                  <c:v>5.049738219895287</c:v>
                </c:pt>
                <c:pt idx="5">
                  <c:v>5.704226421648781</c:v>
                </c:pt>
                <c:pt idx="6">
                  <c:v>5.888299111193426</c:v>
                </c:pt>
                <c:pt idx="7">
                  <c:v>5.678742565000106</c:v>
                </c:pt>
                <c:pt idx="8">
                  <c:v>7.231540807530348</c:v>
                </c:pt>
                <c:pt idx="9">
                  <c:v>6.317030497381322</c:v>
                </c:pt>
                <c:pt idx="10">
                  <c:v>6.328900497466265</c:v>
                </c:pt>
              </c:numCache>
            </c:numRef>
          </c:xVal>
          <c:yVal>
            <c:numRef>
              <c:f>Sheet11!$AJ$14:$AJ$24</c:f>
              <c:numCache>
                <c:formatCode>General</c:formatCode>
                <c:ptCount val="11"/>
                <c:pt idx="0">
                  <c:v>3.0</c:v>
                </c:pt>
                <c:pt idx="1">
                  <c:v>6.0</c:v>
                </c:pt>
                <c:pt idx="2">
                  <c:v>3.0</c:v>
                </c:pt>
                <c:pt idx="3">
                  <c:v>10.0</c:v>
                </c:pt>
                <c:pt idx="4">
                  <c:v>1.0</c:v>
                </c:pt>
                <c:pt idx="5">
                  <c:v>0.0</c:v>
                </c:pt>
                <c:pt idx="6">
                  <c:v>1.0</c:v>
                </c:pt>
                <c:pt idx="7">
                  <c:v>-3.0</c:v>
                </c:pt>
                <c:pt idx="8">
                  <c:v>6.0</c:v>
                </c:pt>
                <c:pt idx="9">
                  <c:v>1.0</c:v>
                </c:pt>
                <c:pt idx="10">
                  <c:v>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5215480"/>
        <c:axId val="-2146749240"/>
      </c:scatterChart>
      <c:valAx>
        <c:axId val="20552154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</a:t>
                </a:r>
              </a:p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In NREM2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6749240"/>
        <c:crosses val="autoZero"/>
        <c:crossBetween val="midCat"/>
        <c:majorUnit val="2.0"/>
      </c:valAx>
      <c:valAx>
        <c:axId val="-2146749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55215480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Twelve hours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Z$2:$Z$13</c:f>
              <c:numCache>
                <c:formatCode>General</c:formatCode>
                <c:ptCount val="12"/>
                <c:pt idx="0">
                  <c:v>4.131694644284572</c:v>
                </c:pt>
                <c:pt idx="1">
                  <c:v>2.084962164576626</c:v>
                </c:pt>
                <c:pt idx="2">
                  <c:v>6.627351455590417</c:v>
                </c:pt>
                <c:pt idx="3">
                  <c:v>7.737595169335786</c:v>
                </c:pt>
                <c:pt idx="4">
                  <c:v>5.694989732768977</c:v>
                </c:pt>
                <c:pt idx="5">
                  <c:v>6.463117106773824</c:v>
                </c:pt>
                <c:pt idx="6">
                  <c:v>6.329019250780437</c:v>
                </c:pt>
                <c:pt idx="7">
                  <c:v>6.087018140589569</c:v>
                </c:pt>
                <c:pt idx="8">
                  <c:v>6.502840174892807</c:v>
                </c:pt>
                <c:pt idx="9">
                  <c:v>5.268232479568662</c:v>
                </c:pt>
                <c:pt idx="10">
                  <c:v>7.033964013902078</c:v>
                </c:pt>
                <c:pt idx="11">
                  <c:v>5.731676280963692</c:v>
                </c:pt>
              </c:numCache>
            </c:numRef>
          </c:xVal>
          <c:yVal>
            <c:numRef>
              <c:f>Sheet11!$AJ$2:$AJ$13</c:f>
              <c:numCache>
                <c:formatCode>General</c:formatCode>
                <c:ptCount val="12"/>
                <c:pt idx="0">
                  <c:v>7.0</c:v>
                </c:pt>
                <c:pt idx="1">
                  <c:v>3.0</c:v>
                </c:pt>
                <c:pt idx="2">
                  <c:v>3.0</c:v>
                </c:pt>
                <c:pt idx="3">
                  <c:v>2.0</c:v>
                </c:pt>
                <c:pt idx="4">
                  <c:v>3.0</c:v>
                </c:pt>
                <c:pt idx="5">
                  <c:v>4.0</c:v>
                </c:pt>
                <c:pt idx="6">
                  <c:v>5.0</c:v>
                </c:pt>
                <c:pt idx="7">
                  <c:v>1.0</c:v>
                </c:pt>
                <c:pt idx="8">
                  <c:v>4.0</c:v>
                </c:pt>
                <c:pt idx="9">
                  <c:v>5.0</c:v>
                </c:pt>
                <c:pt idx="10">
                  <c:v>-1.0</c:v>
                </c:pt>
                <c:pt idx="11">
                  <c:v>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2578312"/>
        <c:axId val="2132674264"/>
      </c:scatterChart>
      <c:valAx>
        <c:axId val="21325783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</a:t>
                </a:r>
              </a:p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In NREM2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2674264"/>
        <c:crosses val="autoZero"/>
        <c:crossBetween val="midCat"/>
        <c:majorUnit val="2.0"/>
      </c:valAx>
      <c:valAx>
        <c:axId val="2132674264"/>
        <c:scaling>
          <c:orientation val="minMax"/>
          <c:max val="15.0"/>
          <c:min val="-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2578312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xVal>
            <c:numRef>
              <c:f>Sheet11!$Z$14:$Z$24</c:f>
              <c:numCache>
                <c:formatCode>General</c:formatCode>
                <c:ptCount val="11"/>
                <c:pt idx="0">
                  <c:v>5.331792051987002</c:v>
                </c:pt>
                <c:pt idx="1">
                  <c:v>3.400207123726744</c:v>
                </c:pt>
                <c:pt idx="2">
                  <c:v>5.510210862841644</c:v>
                </c:pt>
                <c:pt idx="3">
                  <c:v>6.275981169018492</c:v>
                </c:pt>
                <c:pt idx="4">
                  <c:v>5.049738219895287</c:v>
                </c:pt>
                <c:pt idx="5">
                  <c:v>5.704226421648781</c:v>
                </c:pt>
                <c:pt idx="6">
                  <c:v>5.888299111193426</c:v>
                </c:pt>
                <c:pt idx="7">
                  <c:v>5.678742565000106</c:v>
                </c:pt>
                <c:pt idx="8">
                  <c:v>7.231540807530348</c:v>
                </c:pt>
                <c:pt idx="9">
                  <c:v>6.317030497381322</c:v>
                </c:pt>
                <c:pt idx="10">
                  <c:v>6.328900497466265</c:v>
                </c:pt>
              </c:numCache>
            </c:numRef>
          </c:xVal>
          <c:yVal>
            <c:numRef>
              <c:f>Sheet11!$AL$14:$AL$24</c:f>
              <c:numCache>
                <c:formatCode>General</c:formatCode>
                <c:ptCount val="11"/>
                <c:pt idx="0">
                  <c:v>-4.0</c:v>
                </c:pt>
                <c:pt idx="1">
                  <c:v>6.0</c:v>
                </c:pt>
                <c:pt idx="2">
                  <c:v>-2.0</c:v>
                </c:pt>
                <c:pt idx="3">
                  <c:v>8.0</c:v>
                </c:pt>
                <c:pt idx="4">
                  <c:v>2.0</c:v>
                </c:pt>
                <c:pt idx="5">
                  <c:v>-7.0</c:v>
                </c:pt>
                <c:pt idx="6">
                  <c:v>-3.0</c:v>
                </c:pt>
                <c:pt idx="7">
                  <c:v>-3.0</c:v>
                </c:pt>
                <c:pt idx="8">
                  <c:v>5.0</c:v>
                </c:pt>
                <c:pt idx="9">
                  <c:v>-1.0</c:v>
                </c:pt>
                <c:pt idx="10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5749720"/>
        <c:axId val="-2146013688"/>
      </c:scatterChart>
      <c:valAx>
        <c:axId val="-21457497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</a:t>
                </a:r>
              </a:p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In NREM2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6013688"/>
        <c:crosses val="autoZero"/>
        <c:crossBetween val="midCat"/>
      </c:valAx>
      <c:valAx>
        <c:axId val="-2146013688"/>
        <c:scaling>
          <c:orientation val="minMax"/>
          <c:max val="1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</a:t>
                </a:r>
                <a:r>
                  <a:rPr lang="en-US" sz="1000" baseline="0">
                    <a:latin typeface="Arial"/>
                    <a:cs typeface="Arial"/>
                  </a:rPr>
                  <a:t> benefit (pairs)</a:t>
                </a:r>
                <a:endParaRPr lang="en-U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5749720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Z$2:$Z$13</c:f>
              <c:numCache>
                <c:formatCode>General</c:formatCode>
                <c:ptCount val="12"/>
                <c:pt idx="0">
                  <c:v>4.131694644284572</c:v>
                </c:pt>
                <c:pt idx="1">
                  <c:v>2.084962164576626</c:v>
                </c:pt>
                <c:pt idx="2">
                  <c:v>6.627351455590417</c:v>
                </c:pt>
                <c:pt idx="3">
                  <c:v>7.737595169335786</c:v>
                </c:pt>
                <c:pt idx="4">
                  <c:v>5.694989732768977</c:v>
                </c:pt>
                <c:pt idx="5">
                  <c:v>6.463117106773824</c:v>
                </c:pt>
                <c:pt idx="6">
                  <c:v>6.329019250780437</c:v>
                </c:pt>
                <c:pt idx="7">
                  <c:v>6.087018140589569</c:v>
                </c:pt>
                <c:pt idx="8">
                  <c:v>6.502840174892807</c:v>
                </c:pt>
                <c:pt idx="9">
                  <c:v>5.268232479568662</c:v>
                </c:pt>
                <c:pt idx="10">
                  <c:v>7.033964013902078</c:v>
                </c:pt>
                <c:pt idx="11">
                  <c:v>5.731676280963692</c:v>
                </c:pt>
              </c:numCache>
            </c:numRef>
          </c:xVal>
          <c:yVal>
            <c:numRef>
              <c:f>Sheet11!$AL$2:$AL$13</c:f>
              <c:numCache>
                <c:formatCode>General</c:formatCode>
                <c:ptCount val="12"/>
                <c:pt idx="0">
                  <c:v>9.0</c:v>
                </c:pt>
                <c:pt idx="1">
                  <c:v>-6.0</c:v>
                </c:pt>
                <c:pt idx="2">
                  <c:v>0.0</c:v>
                </c:pt>
                <c:pt idx="3">
                  <c:v>5.0</c:v>
                </c:pt>
                <c:pt idx="4">
                  <c:v>-1.0</c:v>
                </c:pt>
                <c:pt idx="5">
                  <c:v>14.0</c:v>
                </c:pt>
                <c:pt idx="6">
                  <c:v>-2.0</c:v>
                </c:pt>
                <c:pt idx="7">
                  <c:v>5.0</c:v>
                </c:pt>
                <c:pt idx="8">
                  <c:v>1.0</c:v>
                </c:pt>
                <c:pt idx="9">
                  <c:v>7.0</c:v>
                </c:pt>
                <c:pt idx="10">
                  <c:v>-6.0</c:v>
                </c:pt>
                <c:pt idx="11">
                  <c:v>-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00612584"/>
        <c:axId val="2101133896"/>
      </c:scatterChart>
      <c:valAx>
        <c:axId val="21006125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</a:t>
                </a:r>
              </a:p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In NREM2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1133896"/>
        <c:crosses val="autoZero"/>
        <c:crossBetween val="midCat"/>
      </c:valAx>
      <c:valAx>
        <c:axId val="2101133896"/>
        <c:scaling>
          <c:orientation val="minMax"/>
          <c:max val="1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</a:t>
                </a:r>
                <a:r>
                  <a:rPr lang="en-US" sz="1000" baseline="0">
                    <a:latin typeface="Arial"/>
                    <a:cs typeface="Arial"/>
                  </a:rPr>
                  <a:t> benefit (pairs)</a:t>
                </a:r>
                <a:endParaRPr lang="en-U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0612584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600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68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944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490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357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205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01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179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273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526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9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135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5821322"/>
              </p:ext>
            </p:extLst>
          </p:nvPr>
        </p:nvGraphicFramePr>
        <p:xfrm>
          <a:off x="1143000" y="543349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8882190"/>
              </p:ext>
            </p:extLst>
          </p:nvPr>
        </p:nvGraphicFramePr>
        <p:xfrm>
          <a:off x="3622874" y="549003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1806458"/>
              </p:ext>
            </p:extLst>
          </p:nvPr>
        </p:nvGraphicFramePr>
        <p:xfrm>
          <a:off x="1143000" y="3435955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9020075"/>
              </p:ext>
            </p:extLst>
          </p:nvPr>
        </p:nvGraphicFramePr>
        <p:xfrm>
          <a:off x="3622874" y="3435955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037528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48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yn</dc:creator>
  <cp:lastModifiedBy>Kathryn</cp:lastModifiedBy>
  <cp:revision>8</cp:revision>
  <dcterms:created xsi:type="dcterms:W3CDTF">2016-02-23T10:51:08Z</dcterms:created>
  <dcterms:modified xsi:type="dcterms:W3CDTF">2016-06-26T21:34:07Z</dcterms:modified>
</cp:coreProperties>
</file>